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9" r:id="rId8"/>
    <p:sldId id="271" r:id="rId9"/>
    <p:sldId id="272" r:id="rId10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097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667" autoAdjust="0"/>
    <p:restoredTop sz="94660"/>
  </p:normalViewPr>
  <p:slideViewPr>
    <p:cSldViewPr snapToGrid="0" showGuides="1">
      <p:cViewPr>
        <p:scale>
          <a:sx n="150" d="100"/>
          <a:sy n="150" d="100"/>
        </p:scale>
        <p:origin x="-720" y="2424"/>
      </p:cViewPr>
      <p:guideLst>
        <p:guide orient="horz" pos="3097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A97EE-A47B-425E-A7BC-35996BCEED7E}" type="datetimeFigureOut">
              <a:rPr lang="en-GB" smtClean="0"/>
              <a:pPr/>
              <a:t>1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20B5BE-B1BF-46B8-85E7-F76B8BAF7D2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7592100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A97EE-A47B-425E-A7BC-35996BCEED7E}" type="datetimeFigureOut">
              <a:rPr lang="en-GB" smtClean="0"/>
              <a:pPr/>
              <a:t>1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20B5BE-B1BF-46B8-85E7-F76B8BAF7D2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8566907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A97EE-A47B-425E-A7BC-35996BCEED7E}" type="datetimeFigureOut">
              <a:rPr lang="en-GB" smtClean="0"/>
              <a:pPr/>
              <a:t>1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20B5BE-B1BF-46B8-85E7-F76B8BAF7D2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0788271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A97EE-A47B-425E-A7BC-35996BCEED7E}" type="datetimeFigureOut">
              <a:rPr lang="en-GB" smtClean="0"/>
              <a:pPr/>
              <a:t>1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20B5BE-B1BF-46B8-85E7-F76B8BAF7D2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2665265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A97EE-A47B-425E-A7BC-35996BCEED7E}" type="datetimeFigureOut">
              <a:rPr lang="en-GB" smtClean="0"/>
              <a:pPr/>
              <a:t>1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20B5BE-B1BF-46B8-85E7-F76B8BAF7D2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900025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A97EE-A47B-425E-A7BC-35996BCEED7E}" type="datetimeFigureOut">
              <a:rPr lang="en-GB" smtClean="0"/>
              <a:pPr/>
              <a:t>19/04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20B5BE-B1BF-46B8-85E7-F76B8BAF7D2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5161962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A97EE-A47B-425E-A7BC-35996BCEED7E}" type="datetimeFigureOut">
              <a:rPr lang="en-GB" smtClean="0"/>
              <a:pPr/>
              <a:t>19/04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20B5BE-B1BF-46B8-85E7-F76B8BAF7D2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256663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A97EE-A47B-425E-A7BC-35996BCEED7E}" type="datetimeFigureOut">
              <a:rPr lang="en-GB" smtClean="0"/>
              <a:pPr/>
              <a:t>19/04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20B5BE-B1BF-46B8-85E7-F76B8BAF7D2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0119501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A97EE-A47B-425E-A7BC-35996BCEED7E}" type="datetimeFigureOut">
              <a:rPr lang="en-GB" smtClean="0"/>
              <a:pPr/>
              <a:t>19/04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20B5BE-B1BF-46B8-85E7-F76B8BAF7D2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748216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A97EE-A47B-425E-A7BC-35996BCEED7E}" type="datetimeFigureOut">
              <a:rPr lang="en-GB" smtClean="0"/>
              <a:pPr/>
              <a:t>19/04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20B5BE-B1BF-46B8-85E7-F76B8BAF7D2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1285235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A97EE-A47B-425E-A7BC-35996BCEED7E}" type="datetimeFigureOut">
              <a:rPr lang="en-GB" smtClean="0"/>
              <a:pPr/>
              <a:t>19/04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20B5BE-B1BF-46B8-85E7-F76B8BAF7D2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0991974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EA97EE-A47B-425E-A7BC-35996BCEED7E}" type="datetimeFigureOut">
              <a:rPr lang="en-GB" smtClean="0"/>
              <a:pPr/>
              <a:t>1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20B5BE-B1BF-46B8-85E7-F76B8BAF7D2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0028280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-3"/>
            <a:ext cx="6858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200" b="1" dirty="0" err="1" smtClean="0"/>
              <a:t>Supplementary</a:t>
            </a:r>
            <a:r>
              <a:rPr lang="da-DK" sz="1200" b="1" dirty="0" smtClean="0"/>
              <a:t> </a:t>
            </a:r>
            <a:r>
              <a:rPr lang="da-DK" sz="1200" b="1" dirty="0" err="1" smtClean="0"/>
              <a:t>figure</a:t>
            </a:r>
            <a:r>
              <a:rPr lang="da-DK" sz="1200" b="1" dirty="0" smtClean="0"/>
              <a:t> S2. </a:t>
            </a:r>
            <a:r>
              <a:rPr lang="da-DK" sz="1200" dirty="0" err="1" smtClean="0"/>
              <a:t>Genome</a:t>
            </a:r>
            <a:r>
              <a:rPr lang="en-GB" sz="1200" dirty="0" smtClean="0"/>
              <a:t>-wide association analysis on traits of 299 </a:t>
            </a:r>
            <a:r>
              <a:rPr lang="en-GB" sz="1200" dirty="0" err="1" smtClean="0"/>
              <a:t>Indica</a:t>
            </a:r>
            <a:r>
              <a:rPr lang="en-GB" sz="1200" dirty="0" smtClean="0"/>
              <a:t> rice accessions. Manhattan and Quantile-Quantile plots were generated using a mixed linear model approach. Peaks above the red threshold line are significant. </a:t>
            </a:r>
            <a:endParaRPr lang="en-GB" sz="12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-3" y="560264"/>
            <a:ext cx="30310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i="1" dirty="0" smtClean="0"/>
              <a:t>K</a:t>
            </a:r>
            <a:r>
              <a:rPr lang="en-GB" sz="1200" baseline="-25000" dirty="0" smtClean="0"/>
              <a:t>i</a:t>
            </a:r>
            <a:r>
              <a:rPr lang="en-GB" sz="1200" dirty="0" smtClean="0"/>
              <a:t> of seeds harvested at 38 days after heading</a:t>
            </a:r>
            <a:endParaRPr lang="en-GB" sz="1200" i="1" dirty="0"/>
          </a:p>
        </p:txBody>
      </p:sp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955643"/>
            <a:ext cx="6858000" cy="38099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0" y="5094879"/>
            <a:ext cx="6858000" cy="38099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xmlns="" val="19152519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-3" y="560264"/>
            <a:ext cx="33500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Slope of seeds harvested at 38 days after heading</a:t>
            </a:r>
            <a:endParaRPr lang="en-GB" sz="1200" i="1" dirty="0"/>
          </a:p>
        </p:txBody>
      </p:sp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5159409"/>
            <a:ext cx="6858000" cy="381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pSp>
        <p:nvGrpSpPr>
          <p:cNvPr id="6" name="Group 5"/>
          <p:cNvGrpSpPr/>
          <p:nvPr/>
        </p:nvGrpSpPr>
        <p:grpSpPr>
          <a:xfrm>
            <a:off x="0" y="958090"/>
            <a:ext cx="6858000" cy="3810000"/>
            <a:chOff x="0" y="958090"/>
            <a:chExt cx="6858000" cy="3810000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0" y="958090"/>
              <a:ext cx="6858000" cy="381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cxnSp>
          <p:nvCxnSpPr>
            <p:cNvPr id="5" name="Straight Connector 4"/>
            <p:cNvCxnSpPr/>
            <p:nvPr/>
          </p:nvCxnSpPr>
          <p:spPr>
            <a:xfrm flipV="1">
              <a:off x="487363" y="1692275"/>
              <a:ext cx="6263640" cy="0"/>
            </a:xfrm>
            <a:prstGeom prst="line">
              <a:avLst/>
            </a:prstGeom>
            <a:ln w="19050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xmlns="" val="631343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-3" y="560264"/>
            <a:ext cx="31080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i="1" dirty="0" smtClean="0"/>
              <a:t>p</a:t>
            </a:r>
            <a:r>
              <a:rPr lang="en-GB" sz="1200" baseline="-25000" dirty="0" smtClean="0"/>
              <a:t>50</a:t>
            </a:r>
            <a:r>
              <a:rPr lang="en-GB" sz="1200" dirty="0" smtClean="0"/>
              <a:t> of seeds harvested at 38 days after heading</a:t>
            </a:r>
            <a:endParaRPr lang="en-GB" sz="1200" i="1" dirty="0"/>
          </a:p>
        </p:txBody>
      </p:sp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5143499"/>
            <a:ext cx="6852352" cy="38068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pSp>
        <p:nvGrpSpPr>
          <p:cNvPr id="6" name="Group 5"/>
          <p:cNvGrpSpPr/>
          <p:nvPr/>
        </p:nvGrpSpPr>
        <p:grpSpPr>
          <a:xfrm>
            <a:off x="1" y="950256"/>
            <a:ext cx="6858000" cy="3810001"/>
            <a:chOff x="1" y="950256"/>
            <a:chExt cx="6858000" cy="3810001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" y="950256"/>
              <a:ext cx="6858000" cy="381000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cxnSp>
          <p:nvCxnSpPr>
            <p:cNvPr id="5" name="Straight Connector 4"/>
            <p:cNvCxnSpPr/>
            <p:nvPr/>
          </p:nvCxnSpPr>
          <p:spPr>
            <a:xfrm flipV="1">
              <a:off x="487363" y="2085975"/>
              <a:ext cx="6263640" cy="0"/>
            </a:xfrm>
            <a:prstGeom prst="line">
              <a:avLst/>
            </a:prstGeom>
            <a:ln w="19050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xmlns="" val="40560648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-3" y="560264"/>
            <a:ext cx="54831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i="1" dirty="0" smtClean="0"/>
              <a:t>K</a:t>
            </a:r>
            <a:r>
              <a:rPr lang="en-GB" sz="1200" baseline="-25000" dirty="0" smtClean="0"/>
              <a:t>i</a:t>
            </a:r>
            <a:r>
              <a:rPr lang="en-GB" sz="1200" dirty="0" smtClean="0"/>
              <a:t> of seeds with highest longevity (</a:t>
            </a:r>
            <a:r>
              <a:rPr lang="en-GB" sz="1200" i="1" dirty="0" smtClean="0"/>
              <a:t>p</a:t>
            </a:r>
            <a:r>
              <a:rPr lang="en-GB" sz="1200" baseline="-25000" dirty="0" smtClean="0"/>
              <a:t>50</a:t>
            </a:r>
            <a:r>
              <a:rPr lang="en-GB" sz="1200" dirty="0" smtClean="0"/>
              <a:t>) harvested at either 38 or 45 days after heading</a:t>
            </a:r>
            <a:endParaRPr lang="en-GB" sz="1200" i="1" dirty="0"/>
          </a:p>
        </p:txBody>
      </p:sp>
      <p:pic>
        <p:nvPicPr>
          <p:cNvPr id="3" name="Picture 2" descr="E:\NEW\Papers\Ongoing\2018_LongevQTL\v6\gwas again\Mht_MLM_ki best coMC.bmp"/>
          <p:cNvPicPr preferRelativeResize="0"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-3" y="903551"/>
            <a:ext cx="6858003" cy="399565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" name="Picture 3" descr="E:\NEW\Papers\Ongoing\2018_LongevQTL\v6\gwas again\QQ_MLM_ki best coMC.bmp"/>
          <p:cNvPicPr preferRelativeResize="0"/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" y="5045247"/>
            <a:ext cx="6858000" cy="39696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xmlns="" val="5525141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-3" y="560264"/>
            <a:ext cx="58630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Slope of seeds with highest longevity (</a:t>
            </a:r>
            <a:r>
              <a:rPr lang="en-GB" sz="1200" i="1" dirty="0" smtClean="0"/>
              <a:t>p</a:t>
            </a:r>
            <a:r>
              <a:rPr lang="en-GB" sz="1200" baseline="-25000" dirty="0" smtClean="0"/>
              <a:t>50</a:t>
            </a:r>
            <a:r>
              <a:rPr lang="en-GB" sz="1200" dirty="0" smtClean="0"/>
              <a:t>) harvested at either 38 or 45 days after heading</a:t>
            </a:r>
            <a:endParaRPr lang="en-GB" sz="1200" i="1" dirty="0"/>
          </a:p>
        </p:txBody>
      </p:sp>
      <p:pic>
        <p:nvPicPr>
          <p:cNvPr id="4" name="Picture 3" descr="E:\NEW\Papers\Ongoing\2018_LongevQTL\v6\gwas again\QQ_MLM_slope best coMC.bmp"/>
          <p:cNvPicPr preferRelativeResize="0"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" y="5056004"/>
            <a:ext cx="6858000" cy="389435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6" name="Group 5"/>
          <p:cNvGrpSpPr/>
          <p:nvPr/>
        </p:nvGrpSpPr>
        <p:grpSpPr>
          <a:xfrm>
            <a:off x="-3" y="837263"/>
            <a:ext cx="6858003" cy="4115737"/>
            <a:chOff x="-3" y="837263"/>
            <a:chExt cx="6858003" cy="4115737"/>
          </a:xfrm>
        </p:grpSpPr>
        <p:pic>
          <p:nvPicPr>
            <p:cNvPr id="3" name="Picture 2" descr="E:\NEW\Papers\Ongoing\2018_LongevQTL\v6\gwas again\Mht_MLM_slope best.bmp"/>
            <p:cNvPicPr preferRelativeResize="0"/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-3" y="837263"/>
              <a:ext cx="6858003" cy="41157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5" name="Straight Connector 4"/>
            <p:cNvCxnSpPr/>
            <p:nvPr/>
          </p:nvCxnSpPr>
          <p:spPr>
            <a:xfrm flipV="1">
              <a:off x="487363" y="1717675"/>
              <a:ext cx="6263640" cy="0"/>
            </a:xfrm>
            <a:prstGeom prst="line">
              <a:avLst/>
            </a:prstGeom>
            <a:ln w="19050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xmlns="" val="33289559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-3" y="560264"/>
            <a:ext cx="55953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i="1" dirty="0" smtClean="0"/>
              <a:t>p</a:t>
            </a:r>
            <a:r>
              <a:rPr lang="en-GB" sz="1200" baseline="-25000" dirty="0" smtClean="0"/>
              <a:t>50</a:t>
            </a:r>
            <a:r>
              <a:rPr lang="en-GB" sz="1200" dirty="0" smtClean="0"/>
              <a:t> of seeds with highest longevity (</a:t>
            </a:r>
            <a:r>
              <a:rPr lang="en-GB" sz="1200" i="1" dirty="0" smtClean="0"/>
              <a:t>p</a:t>
            </a:r>
            <a:r>
              <a:rPr lang="en-GB" sz="1200" baseline="-25000" dirty="0" smtClean="0"/>
              <a:t>50</a:t>
            </a:r>
            <a:r>
              <a:rPr lang="en-GB" sz="1200" dirty="0" smtClean="0"/>
              <a:t>) harvested at either 38 or 45 days after heading</a:t>
            </a:r>
            <a:endParaRPr lang="en-GB" sz="1200" i="1" dirty="0"/>
          </a:p>
        </p:txBody>
      </p:sp>
      <p:pic>
        <p:nvPicPr>
          <p:cNvPr id="4" name="Picture 3" descr="E:\NEW\Papers\Ongoing\2018_LongevQTL\v6\gwas again\QQ_MLM_p50 best coMC.bmp"/>
          <p:cNvPicPr preferRelativeResize="0"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5071338"/>
            <a:ext cx="6858001" cy="37714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6" name="Group 5"/>
          <p:cNvGrpSpPr/>
          <p:nvPr/>
        </p:nvGrpSpPr>
        <p:grpSpPr>
          <a:xfrm>
            <a:off x="1" y="880295"/>
            <a:ext cx="6858000" cy="3949890"/>
            <a:chOff x="1" y="880295"/>
            <a:chExt cx="6858000" cy="3949890"/>
          </a:xfrm>
        </p:grpSpPr>
        <p:pic>
          <p:nvPicPr>
            <p:cNvPr id="3" name="Picture 2" descr="E:\NEW\Papers\Ongoing\2018_LongevQTL\v6\gwas again\Mht_MLM_p50 best coMC.bmp"/>
            <p:cNvPicPr preferRelativeResize="0"/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" y="880295"/>
              <a:ext cx="6858000" cy="394989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5" name="Straight Connector 4"/>
            <p:cNvCxnSpPr/>
            <p:nvPr/>
          </p:nvCxnSpPr>
          <p:spPr>
            <a:xfrm flipV="1">
              <a:off x="487363" y="1920875"/>
              <a:ext cx="6263640" cy="0"/>
            </a:xfrm>
            <a:prstGeom prst="line">
              <a:avLst/>
            </a:prstGeom>
            <a:ln w="19050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xmlns="" val="41654348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-3" y="560264"/>
            <a:ext cx="12367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100-grain weight</a:t>
            </a:r>
            <a:endParaRPr lang="en-GB" sz="1200" dirty="0"/>
          </a:p>
        </p:txBody>
      </p:sp>
      <p:pic>
        <p:nvPicPr>
          <p:cNvPr id="4" name="Picture 3"/>
          <p:cNvPicPr preferRelativeResize="0"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4805968"/>
            <a:ext cx="6858000" cy="3466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pSp>
        <p:nvGrpSpPr>
          <p:cNvPr id="6" name="Group 5"/>
          <p:cNvGrpSpPr/>
          <p:nvPr/>
        </p:nvGrpSpPr>
        <p:grpSpPr>
          <a:xfrm>
            <a:off x="0" y="837263"/>
            <a:ext cx="6858000" cy="3691706"/>
            <a:chOff x="0" y="837263"/>
            <a:chExt cx="6858000" cy="3691706"/>
          </a:xfrm>
        </p:grpSpPr>
        <p:pic>
          <p:nvPicPr>
            <p:cNvPr id="3" name="Picture 2"/>
            <p:cNvPicPr preferRelativeResize="0">
              <a:picLocks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0" y="837263"/>
              <a:ext cx="6858000" cy="36917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cxnSp>
          <p:nvCxnSpPr>
            <p:cNvPr id="5" name="Straight Connector 4"/>
            <p:cNvCxnSpPr/>
            <p:nvPr/>
          </p:nvCxnSpPr>
          <p:spPr>
            <a:xfrm flipV="1">
              <a:off x="487363" y="1558925"/>
              <a:ext cx="6263640" cy="0"/>
            </a:xfrm>
            <a:prstGeom prst="line">
              <a:avLst/>
            </a:prstGeom>
            <a:ln w="19050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xmlns="" val="37736198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-3" y="560264"/>
            <a:ext cx="9659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Antioxidants</a:t>
            </a:r>
          </a:p>
        </p:txBody>
      </p:sp>
      <p:pic>
        <p:nvPicPr>
          <p:cNvPr id="4" name="Picture 3"/>
          <p:cNvPicPr preferRelativeResize="0"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-3" y="5143500"/>
            <a:ext cx="6858003" cy="35164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pSp>
        <p:nvGrpSpPr>
          <p:cNvPr id="6" name="Group 5"/>
          <p:cNvGrpSpPr/>
          <p:nvPr/>
        </p:nvGrpSpPr>
        <p:grpSpPr>
          <a:xfrm>
            <a:off x="0" y="837263"/>
            <a:ext cx="6858000" cy="4079225"/>
            <a:chOff x="0" y="837263"/>
            <a:chExt cx="6858000" cy="4079225"/>
          </a:xfrm>
        </p:grpSpPr>
        <p:pic>
          <p:nvPicPr>
            <p:cNvPr id="3" name="Picture 2"/>
            <p:cNvPicPr preferRelativeResize="0">
              <a:picLocks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0" y="837263"/>
              <a:ext cx="6858000" cy="4079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cxnSp>
          <p:nvCxnSpPr>
            <p:cNvPr id="5" name="Straight Connector 4"/>
            <p:cNvCxnSpPr/>
            <p:nvPr/>
          </p:nvCxnSpPr>
          <p:spPr>
            <a:xfrm flipV="1">
              <a:off x="519113" y="2695575"/>
              <a:ext cx="6217920" cy="0"/>
            </a:xfrm>
            <a:prstGeom prst="line">
              <a:avLst/>
            </a:prstGeom>
            <a:ln w="19050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xmlns="" val="30730156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-3" y="560264"/>
            <a:ext cx="7809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err="1" smtClean="0"/>
              <a:t>Phenolics</a:t>
            </a:r>
            <a:endParaRPr lang="en-GB" sz="1200" dirty="0" smtClean="0"/>
          </a:p>
        </p:txBody>
      </p:sp>
      <p:pic>
        <p:nvPicPr>
          <p:cNvPr id="4" name="Picture 3"/>
          <p:cNvPicPr preferRelativeResize="0"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4916488"/>
            <a:ext cx="6858000" cy="36573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pSp>
        <p:nvGrpSpPr>
          <p:cNvPr id="6" name="Group 5"/>
          <p:cNvGrpSpPr/>
          <p:nvPr/>
        </p:nvGrpSpPr>
        <p:grpSpPr>
          <a:xfrm>
            <a:off x="-3" y="958103"/>
            <a:ext cx="6858003" cy="3710716"/>
            <a:chOff x="-3" y="958103"/>
            <a:chExt cx="6858003" cy="3710716"/>
          </a:xfrm>
        </p:grpSpPr>
        <p:pic>
          <p:nvPicPr>
            <p:cNvPr id="3" name="Picture 2"/>
            <p:cNvPicPr preferRelativeResize="0">
              <a:picLocks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-3" y="958103"/>
              <a:ext cx="6858003" cy="37107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cxnSp>
          <p:nvCxnSpPr>
            <p:cNvPr id="5" name="Straight Connector 4"/>
            <p:cNvCxnSpPr/>
            <p:nvPr/>
          </p:nvCxnSpPr>
          <p:spPr>
            <a:xfrm flipV="1">
              <a:off x="531813" y="3057525"/>
              <a:ext cx="6217920" cy="0"/>
            </a:xfrm>
            <a:prstGeom prst="line">
              <a:avLst/>
            </a:prstGeom>
            <a:ln w="19050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xmlns="" val="24283208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</TotalTime>
  <Words>123</Words>
  <Application>Microsoft Office PowerPoint</Application>
  <PresentationFormat>A4 Paper (210x297 mm)</PresentationFormat>
  <Paragraphs>10</Paragraphs>
  <Slides>9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</vt:vector>
  </TitlesOfParts>
  <Company>Aarhus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iona Ruth Hay</dc:creator>
  <cp:lastModifiedBy>JSLee</cp:lastModifiedBy>
  <cp:revision>18</cp:revision>
  <dcterms:created xsi:type="dcterms:W3CDTF">2018-05-11T08:08:15Z</dcterms:created>
  <dcterms:modified xsi:type="dcterms:W3CDTF">2019-04-19T13:58:25Z</dcterms:modified>
</cp:coreProperties>
</file>